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Default Extension="wdp" ContentType="image/vnd.ms-photo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418" r:id="rId2"/>
    <p:sldId id="450" r:id="rId3"/>
    <p:sldId id="451" r:id="rId4"/>
    <p:sldId id="384" r:id="rId5"/>
    <p:sldId id="411" r:id="rId6"/>
    <p:sldId id="426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A24ED0DD-1480-DD41-AC8E-B3D021FA4833}">
          <p14:sldIdLst/>
        </p14:section>
        <p14:section name="Clean Figures" id="{CC8FE226-6F97-CE46-828A-60EFE79AE999}">
          <p14:sldIdLst/>
        </p14:section>
        <p14:section name="Supplemental Figures" id="{795A6A63-BCFD-CC42-9B1F-A79A964A5DCC}">
          <p14:sldIdLst>
            <p14:sldId id="418"/>
            <p14:sldId id="450"/>
            <p14:sldId id="451"/>
            <p14:sldId id="384"/>
            <p14:sldId id="411"/>
            <p14:sldId id="426"/>
          </p14:sldIdLst>
        </p14:section>
        <p14:section name="OLD-NOTES ON SLIDES" id="{68BDEAF2-15DB-A846-B397-D8AC9E0D0F01}">
          <p14:sldIdLst/>
        </p14:section>
      </p14:sectionLst>
    </p:ext>
    <p:ext uri="{EFAFB233-063F-42B5-8137-9DF3F51BA10A}">
      <p15:sldGuideLst xmlns:p15="http://schemas.microsoft.com/office/powerpoint/2012/main" xmlns="">
        <p15:guide id="1" orient="horz" pos="1389" userDrawn="1">
          <p15:clr>
            <a:srgbClr val="A4A3A4"/>
          </p15:clr>
        </p15:guide>
        <p15:guide id="2" pos="3160" userDrawn="1">
          <p15:clr>
            <a:srgbClr val="A4A3A4"/>
          </p15:clr>
        </p15:guide>
        <p15:guide id="3" orient="horz" pos="2387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BA207A0C-C002-793B-3B25-7D3CAA46EAB2}" name="Kim, Hannah" initials="HK" userId="S::hannah.kim@ubc.ca::255d7e54-643a-4d01-84c2-fb419c08743b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8CCAD"/>
    <a:srgbClr val="C6E0B4"/>
    <a:srgbClr val="FFE79A"/>
    <a:srgbClr val="4472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9154"/>
    <p:restoredTop sz="91497"/>
  </p:normalViewPr>
  <p:slideViewPr>
    <p:cSldViewPr snapToGrid="0">
      <p:cViewPr varScale="1">
        <p:scale>
          <a:sx n="64" d="100"/>
          <a:sy n="64" d="100"/>
        </p:scale>
        <p:origin x="-112" y="-288"/>
      </p:cViewPr>
      <p:guideLst>
        <p:guide orient="horz" pos="1389"/>
        <p:guide orient="horz" pos="2387"/>
        <p:guide pos="3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4" Type="http://schemas.microsoft.com/office/2018/10/relationships/authors" Target="author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notesMaster" Target="notesMasters/notesMaster1.xml"/><Relationship Id="rId9" Type="http://schemas.openxmlformats.org/officeDocument/2006/relationships/printerSettings" Target="printerSettings/printerSettings1.bin"/><Relationship Id="rId10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A1109D0-B871-374F-9F0C-CE3471574A9F}" type="datetimeFigureOut">
              <a:rPr lang="en-US" smtClean="0"/>
              <a:t>28/01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443C073-A8F8-D240-ABD6-63C3FBFE9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3384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VOA10841 western from Josh’s BC Cancer Summit presentation (Nov 22 2019)</a:t>
            </a: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4F058C0-F6EF-5C46-81DA-F15A91B6FCD8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26107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083A2F7-56B7-22B3-DCC1-932E8399F48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3FA1D6D0-1C84-E286-D38A-07AB881A51F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176F588-E0BC-5185-8D45-EC5C89C66E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9533A-E406-694B-A904-90B42D2BE0F0}" type="datetimeFigureOut">
              <a:rPr lang="en-US" smtClean="0"/>
              <a:t>28/01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6435AC4-D9C2-B58D-76CB-8E68724EBC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D9F41CE-7088-379C-CCE1-F00D2BBCCC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4CE07-CDEA-F146-B452-5EF40DF28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5389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6332308-5B1D-9502-6EE0-279B9692C5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5AFC43B8-8C90-1562-36D0-8E68890B5E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9334EC89-DFDB-F8CB-E8D2-17CDB55E28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9533A-E406-694B-A904-90B42D2BE0F0}" type="datetimeFigureOut">
              <a:rPr lang="en-US" smtClean="0"/>
              <a:t>28/01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2DF2960-8214-7940-1F26-65CF5EAE8F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3613BFA8-7E29-16AA-4C89-8EA7D1550E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4CE07-CDEA-F146-B452-5EF40DF28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86941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8F69FF7A-E577-A211-96FB-0E130525262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FC57CAE2-81DD-A98F-0B0D-CC9DAE44AA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CC98EB8-C96E-4DDC-7F02-D0BAEF0032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9533A-E406-694B-A904-90B42D2BE0F0}" type="datetimeFigureOut">
              <a:rPr lang="en-US" smtClean="0"/>
              <a:t>28/01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37DED3DC-85CC-DA20-2BC4-59C2094D69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BCA75C7-E7B4-BCAA-2E30-E8D07D4484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4CE07-CDEA-F146-B452-5EF40DF28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70481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3FBBCCA-679E-563D-8760-5D643AE9A4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AC78F216-25E3-2176-4224-2B52C71E93F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623A5000-9EFA-3EB1-99ED-47DD434C02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9533A-E406-694B-A904-90B42D2BE0F0}" type="datetimeFigureOut">
              <a:rPr lang="en-US" smtClean="0"/>
              <a:t>28/01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EDA3F29B-182E-FFB6-6D54-6F6329C3C0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7F4C4EB5-EDBD-6AFF-0559-C882133AB5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4CE07-CDEA-F146-B452-5EF40DF28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7331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56305B3-68B7-9D8B-2FC8-90345D373A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15722768-1AD0-82FD-DBD6-9190308439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BCE7353-E09D-8518-957E-A3F9E4715A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9533A-E406-694B-A904-90B42D2BE0F0}" type="datetimeFigureOut">
              <a:rPr lang="en-US" smtClean="0"/>
              <a:t>28/01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BA39DC4-D97D-C736-46AB-2B095D6A98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4F1474D6-3895-9F61-E518-12D3698F53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4CE07-CDEA-F146-B452-5EF40DF28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44396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ABD173A-EE23-B744-07D7-A22C2A513D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B28A0E45-4560-857F-4EAD-73EDB022D4C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5B2D0AB5-4BCB-7DE2-7404-C2A4839DB62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D2DC892A-A2B8-3ABC-D77A-11316B59A8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9533A-E406-694B-A904-90B42D2BE0F0}" type="datetimeFigureOut">
              <a:rPr lang="en-US" smtClean="0"/>
              <a:t>28/01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A1689374-A155-A091-876F-9CC65DFE67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2162FD6A-998F-F11B-D529-63B4C5188F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4CE07-CDEA-F146-B452-5EF40DF28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0219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6F65A20-EB31-BB73-06DD-BC4DA63C24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3DD5F3AD-53B6-F6D1-B2B7-1EC388042D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D0E5A0E0-60E8-5B60-B5C0-2234F9E1E7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7A574299-021E-932A-F5D8-8B0E356D761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E304EFF2-7CB0-F5AA-18DA-EFFCCCDC0D0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450B0491-2B56-3AFB-1ACE-C4FF4C2E8C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9533A-E406-694B-A904-90B42D2BE0F0}" type="datetimeFigureOut">
              <a:rPr lang="en-US" smtClean="0"/>
              <a:t>28/01/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81E8DA0C-E7C5-1D59-4E81-8FD174D307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36CB80AD-C180-3109-300C-E53A687455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4CE07-CDEA-F146-B452-5EF40DF28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75639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4BA94BA-C15B-C163-D919-94F7E18841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B3E4C543-8B78-BCB6-23C0-BEB9F5E35C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9533A-E406-694B-A904-90B42D2BE0F0}" type="datetimeFigureOut">
              <a:rPr lang="en-US" smtClean="0"/>
              <a:t>28/01/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11C5EC61-031E-F439-E690-B3F6BA40BA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8E735913-6CF9-BD22-A928-BA0322C04C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4CE07-CDEA-F146-B452-5EF40DF28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25511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63FF3364-0988-B388-CFD5-E5F58FE1F2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9533A-E406-694B-A904-90B42D2BE0F0}" type="datetimeFigureOut">
              <a:rPr lang="en-US" smtClean="0"/>
              <a:t>28/01/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2B532015-D950-482C-80C0-6404DFC30A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3B1B2205-1D20-6D97-4EB4-8360CF8789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4CE07-CDEA-F146-B452-5EF40DF28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536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ECCFEAD-0D0B-EE67-338A-E6E441981C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7944E0A6-DA56-0089-D365-6F8CCB5AF22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34D5571F-4169-2F85-22AB-AE9737E823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41F56769-CEF3-55BD-41A4-DBDF1A4E2B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9533A-E406-694B-A904-90B42D2BE0F0}" type="datetimeFigureOut">
              <a:rPr lang="en-US" smtClean="0"/>
              <a:t>28/01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34F9FE64-7789-A185-F17D-8D74FB32C1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1259A138-AA91-3BE3-9C2B-9647815C37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4CE07-CDEA-F146-B452-5EF40DF28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18720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D1FD873-5AC7-1012-8E87-9E3BB4FCC6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97B87C0C-FEB0-C1C9-42AC-447C0F89BF9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F936D97F-AE85-A337-860B-B9F681F632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4642ACF9-95A6-8CB2-2DA2-0CED7B8B38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79533A-E406-694B-A904-90B42D2BE0F0}" type="datetimeFigureOut">
              <a:rPr lang="en-US" smtClean="0"/>
              <a:t>28/01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EDA21A20-93DD-32E0-9811-5BEEE3F558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5F190A36-7B1C-2EA2-909D-1A0C6FCC73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D4CE07-CDEA-F146-B452-5EF40DF28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3187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D37B26D3-7503-1810-D5A8-8D09F985AD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00A5D40D-7CBA-90B8-3D60-A27D10DC0A7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29180FA-8999-34DA-3179-E772D10483E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79533A-E406-694B-A904-90B42D2BE0F0}" type="datetimeFigureOut">
              <a:rPr lang="en-US" smtClean="0"/>
              <a:t>28/01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E325DF13-F643-6657-4876-88652088B9C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B740D07-9135-32C1-38AA-49D096A10AA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D4CE07-CDEA-F146-B452-5EF40DF28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92271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Relationship Id="rId3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4" Type="http://schemas.openxmlformats.org/officeDocument/2006/relationships/image" Target="../media/image6.png"/><Relationship Id="rId5" Type="http://schemas.microsoft.com/office/2007/relationships/hdphoto" Target="../media/hdphoto1.wdp"/><Relationship Id="rId6" Type="http://schemas.openxmlformats.org/officeDocument/2006/relationships/image" Target="../media/image7.png"/><Relationship Id="rId7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4" Type="http://schemas.openxmlformats.org/officeDocument/2006/relationships/image" Target="../media/image11.png"/><Relationship Id="rId5" Type="http://schemas.openxmlformats.org/officeDocument/2006/relationships/image" Target="../media/image12.emf"/><Relationship Id="rId6" Type="http://schemas.openxmlformats.org/officeDocument/2006/relationships/image" Target="../media/image13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.emf"/><Relationship Id="rId3" Type="http://schemas.openxmlformats.org/officeDocument/2006/relationships/image" Target="../media/image1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C2A39637-805A-F62B-E6BB-75605B884DD2}"/>
              </a:ext>
            </a:extLst>
          </p:cNvPr>
          <p:cNvSpPr txBox="1"/>
          <p:nvPr/>
        </p:nvSpPr>
        <p:spPr>
          <a:xfrm>
            <a:off x="305789" y="160309"/>
            <a:ext cx="1139140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immunohistochemical stains (10x) in LGSOC tumors included in our tissue microarrays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93AABDC0-8BF5-540E-FC16-3BA48E3CC67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1070517"/>
            <a:ext cx="7772400" cy="4371975"/>
          </a:xfrm>
          <a:prstGeom prst="rect">
            <a:avLst/>
          </a:prstGeom>
        </p:spPr>
      </p:pic>
      <p:grpSp>
        <p:nvGrpSpPr>
          <p:cNvPr id="4" name="Group 3">
            <a:extLst>
              <a:ext uri="{FF2B5EF4-FFF2-40B4-BE49-F238E27FC236}">
                <a16:creationId xmlns:a16="http://schemas.microsoft.com/office/drawing/2014/main" xmlns="" id="{4E504DEA-3A60-046F-556C-ACD67EC9FBF4}"/>
              </a:ext>
            </a:extLst>
          </p:cNvPr>
          <p:cNvGrpSpPr/>
          <p:nvPr/>
        </p:nvGrpSpPr>
        <p:grpSpPr>
          <a:xfrm>
            <a:off x="2606195" y="2849802"/>
            <a:ext cx="402481" cy="169277"/>
            <a:chOff x="6074038" y="2815446"/>
            <a:chExt cx="402481" cy="169277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xmlns="" id="{C4C9356A-BAAB-D2F8-886D-6A558EA7C457}"/>
                </a:ext>
              </a:extLst>
            </p:cNvPr>
            <p:cNvSpPr txBox="1"/>
            <p:nvPr/>
          </p:nvSpPr>
          <p:spPr>
            <a:xfrm>
              <a:off x="6074038" y="2815446"/>
              <a:ext cx="40248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/>
                <a:t>200uM</a:t>
              </a:r>
            </a:p>
          </p:txBody>
        </p: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xmlns="" id="{CF940980-EB08-FD66-2A40-62CF5FEB8277}"/>
                </a:ext>
              </a:extLst>
            </p:cNvPr>
            <p:cNvGrpSpPr/>
            <p:nvPr/>
          </p:nvGrpSpPr>
          <p:grpSpPr>
            <a:xfrm>
              <a:off x="6096000" y="2911475"/>
              <a:ext cx="316800" cy="31750"/>
              <a:chOff x="6096000" y="2911475"/>
              <a:chExt cx="316800" cy="31750"/>
            </a:xfrm>
          </p:grpSpPr>
          <p:cxnSp>
            <p:nvCxnSpPr>
              <p:cNvPr id="8" name="Straight Connector 7">
                <a:extLst>
                  <a:ext uri="{FF2B5EF4-FFF2-40B4-BE49-F238E27FC236}">
                    <a16:creationId xmlns:a16="http://schemas.microsoft.com/office/drawing/2014/main" xmlns="" id="{4E7EDF72-7BC7-7EEB-955D-2AE3CB6F2BFD}"/>
                  </a:ext>
                </a:extLst>
              </p:cNvPr>
              <p:cNvCxnSpPr/>
              <p:nvPr/>
            </p:nvCxnSpPr>
            <p:spPr>
              <a:xfrm>
                <a:off x="6096000" y="2942276"/>
                <a:ext cx="3168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9" name="Straight Connector 8">
                <a:extLst>
                  <a:ext uri="{FF2B5EF4-FFF2-40B4-BE49-F238E27FC236}">
                    <a16:creationId xmlns:a16="http://schemas.microsoft.com/office/drawing/2014/main" xmlns="" id="{5F9A1187-4BD0-938B-C270-7978CFE096F8}"/>
                  </a:ext>
                </a:extLst>
              </p:cNvPr>
              <p:cNvCxnSpPr/>
              <p:nvPr/>
            </p:nvCxnSpPr>
            <p:spPr>
              <a:xfrm>
                <a:off x="6096000" y="2911475"/>
                <a:ext cx="0" cy="3175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0" name="Straight Connector 9">
                <a:extLst>
                  <a:ext uri="{FF2B5EF4-FFF2-40B4-BE49-F238E27FC236}">
                    <a16:creationId xmlns:a16="http://schemas.microsoft.com/office/drawing/2014/main" xmlns="" id="{9008F619-0B23-68C8-3B43-21F831404AAD}"/>
                  </a:ext>
                </a:extLst>
              </p:cNvPr>
              <p:cNvCxnSpPr/>
              <p:nvPr/>
            </p:nvCxnSpPr>
            <p:spPr>
              <a:xfrm>
                <a:off x="6410325" y="2911475"/>
                <a:ext cx="0" cy="3175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xmlns="" id="{36E685AF-DC5F-92B7-816D-E1615D6411A7}"/>
              </a:ext>
            </a:extLst>
          </p:cNvPr>
          <p:cNvGrpSpPr/>
          <p:nvPr/>
        </p:nvGrpSpPr>
        <p:grpSpPr>
          <a:xfrm>
            <a:off x="4623730" y="2849802"/>
            <a:ext cx="402481" cy="169277"/>
            <a:chOff x="6074038" y="2815446"/>
            <a:chExt cx="402481" cy="169277"/>
          </a:xfrm>
        </p:grpSpPr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xmlns="" id="{CF26BD6C-AEF5-E686-E1F4-75996C4CA66D}"/>
                </a:ext>
              </a:extLst>
            </p:cNvPr>
            <p:cNvSpPr txBox="1"/>
            <p:nvPr/>
          </p:nvSpPr>
          <p:spPr>
            <a:xfrm>
              <a:off x="6074038" y="2815446"/>
              <a:ext cx="40248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/>
                <a:t>200uM</a:t>
              </a:r>
            </a:p>
          </p:txBody>
        </p: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xmlns="" id="{E9227793-1F80-B6F3-34A5-414DFD59C2C0}"/>
                </a:ext>
              </a:extLst>
            </p:cNvPr>
            <p:cNvGrpSpPr/>
            <p:nvPr/>
          </p:nvGrpSpPr>
          <p:grpSpPr>
            <a:xfrm>
              <a:off x="6096000" y="2911475"/>
              <a:ext cx="316800" cy="31750"/>
              <a:chOff x="6096000" y="2911475"/>
              <a:chExt cx="316800" cy="31750"/>
            </a:xfrm>
          </p:grpSpPr>
          <p:cxnSp>
            <p:nvCxnSpPr>
              <p:cNvPr id="14" name="Straight Connector 13">
                <a:extLst>
                  <a:ext uri="{FF2B5EF4-FFF2-40B4-BE49-F238E27FC236}">
                    <a16:creationId xmlns:a16="http://schemas.microsoft.com/office/drawing/2014/main" xmlns="" id="{70F6DCE7-7D5D-F6F7-4F16-478225C4D2D6}"/>
                  </a:ext>
                </a:extLst>
              </p:cNvPr>
              <p:cNvCxnSpPr/>
              <p:nvPr/>
            </p:nvCxnSpPr>
            <p:spPr>
              <a:xfrm>
                <a:off x="6096000" y="2942276"/>
                <a:ext cx="3168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>
                <a:extLst>
                  <a:ext uri="{FF2B5EF4-FFF2-40B4-BE49-F238E27FC236}">
                    <a16:creationId xmlns:a16="http://schemas.microsoft.com/office/drawing/2014/main" xmlns="" id="{AFA00C2E-E790-0F62-7635-40FDF4816EAB}"/>
                  </a:ext>
                </a:extLst>
              </p:cNvPr>
              <p:cNvCxnSpPr/>
              <p:nvPr/>
            </p:nvCxnSpPr>
            <p:spPr>
              <a:xfrm>
                <a:off x="6096000" y="2911475"/>
                <a:ext cx="0" cy="3175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" name="Straight Connector 15">
                <a:extLst>
                  <a:ext uri="{FF2B5EF4-FFF2-40B4-BE49-F238E27FC236}">
                    <a16:creationId xmlns:a16="http://schemas.microsoft.com/office/drawing/2014/main" xmlns="" id="{90783AFB-5528-2AF5-AF14-841715B3123E}"/>
                  </a:ext>
                </a:extLst>
              </p:cNvPr>
              <p:cNvCxnSpPr/>
              <p:nvPr/>
            </p:nvCxnSpPr>
            <p:spPr>
              <a:xfrm>
                <a:off x="6410325" y="2911475"/>
                <a:ext cx="0" cy="3175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17" name="Group 16">
            <a:extLst>
              <a:ext uri="{FF2B5EF4-FFF2-40B4-BE49-F238E27FC236}">
                <a16:creationId xmlns:a16="http://schemas.microsoft.com/office/drawing/2014/main" xmlns="" id="{F995D524-BEB4-40AD-3E3D-14621BFEE7B4}"/>
              </a:ext>
            </a:extLst>
          </p:cNvPr>
          <p:cNvGrpSpPr/>
          <p:nvPr/>
        </p:nvGrpSpPr>
        <p:grpSpPr>
          <a:xfrm>
            <a:off x="6440024" y="2845399"/>
            <a:ext cx="402481" cy="169277"/>
            <a:chOff x="6074038" y="2815446"/>
            <a:chExt cx="402481" cy="169277"/>
          </a:xfrm>
        </p:grpSpPr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xmlns="" id="{88211102-DB8A-9058-02D4-F11E64883526}"/>
                </a:ext>
              </a:extLst>
            </p:cNvPr>
            <p:cNvSpPr txBox="1"/>
            <p:nvPr/>
          </p:nvSpPr>
          <p:spPr>
            <a:xfrm>
              <a:off x="6074038" y="2815446"/>
              <a:ext cx="40248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/>
                <a:t>200uM</a:t>
              </a:r>
            </a:p>
          </p:txBody>
        </p: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xmlns="" id="{FE91795B-B170-A4EA-18E8-D5A4EC435980}"/>
                </a:ext>
              </a:extLst>
            </p:cNvPr>
            <p:cNvGrpSpPr/>
            <p:nvPr/>
          </p:nvGrpSpPr>
          <p:grpSpPr>
            <a:xfrm>
              <a:off x="6096000" y="2911475"/>
              <a:ext cx="316800" cy="31750"/>
              <a:chOff x="6096000" y="2911475"/>
              <a:chExt cx="316800" cy="31750"/>
            </a:xfrm>
          </p:grpSpPr>
          <p:cxnSp>
            <p:nvCxnSpPr>
              <p:cNvPr id="20" name="Straight Connector 19">
                <a:extLst>
                  <a:ext uri="{FF2B5EF4-FFF2-40B4-BE49-F238E27FC236}">
                    <a16:creationId xmlns:a16="http://schemas.microsoft.com/office/drawing/2014/main" xmlns="" id="{2D93F10C-DB72-B8DF-BC92-6DCC05FB87A8}"/>
                  </a:ext>
                </a:extLst>
              </p:cNvPr>
              <p:cNvCxnSpPr/>
              <p:nvPr/>
            </p:nvCxnSpPr>
            <p:spPr>
              <a:xfrm>
                <a:off x="6096000" y="2942276"/>
                <a:ext cx="3168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1" name="Straight Connector 20">
                <a:extLst>
                  <a:ext uri="{FF2B5EF4-FFF2-40B4-BE49-F238E27FC236}">
                    <a16:creationId xmlns:a16="http://schemas.microsoft.com/office/drawing/2014/main" xmlns="" id="{15BB30F8-0B63-90B2-AD2D-A44EFE89E53C}"/>
                  </a:ext>
                </a:extLst>
              </p:cNvPr>
              <p:cNvCxnSpPr/>
              <p:nvPr/>
            </p:nvCxnSpPr>
            <p:spPr>
              <a:xfrm>
                <a:off x="6096000" y="2911475"/>
                <a:ext cx="0" cy="3175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>
                <a:extLst>
                  <a:ext uri="{FF2B5EF4-FFF2-40B4-BE49-F238E27FC236}">
                    <a16:creationId xmlns:a16="http://schemas.microsoft.com/office/drawing/2014/main" xmlns="" id="{E8AF36ED-175C-BF4C-8F73-39A2DC698B01}"/>
                  </a:ext>
                </a:extLst>
              </p:cNvPr>
              <p:cNvCxnSpPr/>
              <p:nvPr/>
            </p:nvCxnSpPr>
            <p:spPr>
              <a:xfrm>
                <a:off x="6410325" y="2911475"/>
                <a:ext cx="0" cy="3175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3" name="Group 22">
            <a:extLst>
              <a:ext uri="{FF2B5EF4-FFF2-40B4-BE49-F238E27FC236}">
                <a16:creationId xmlns:a16="http://schemas.microsoft.com/office/drawing/2014/main" xmlns="" id="{14626B82-9BDD-5E7F-E318-415F0721B2A1}"/>
              </a:ext>
            </a:extLst>
          </p:cNvPr>
          <p:cNvGrpSpPr/>
          <p:nvPr/>
        </p:nvGrpSpPr>
        <p:grpSpPr>
          <a:xfrm>
            <a:off x="2628157" y="5016308"/>
            <a:ext cx="402481" cy="169277"/>
            <a:chOff x="6074038" y="2815446"/>
            <a:chExt cx="402481" cy="169277"/>
          </a:xfrm>
        </p:grpSpPr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xmlns="" id="{EAF6198B-1EE8-F39A-8B97-84594BF86562}"/>
                </a:ext>
              </a:extLst>
            </p:cNvPr>
            <p:cNvSpPr txBox="1"/>
            <p:nvPr/>
          </p:nvSpPr>
          <p:spPr>
            <a:xfrm>
              <a:off x="6074038" y="2815446"/>
              <a:ext cx="40248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/>
                <a:t>200uM</a:t>
              </a:r>
            </a:p>
          </p:txBody>
        </p: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xmlns="" id="{C16D21A5-AB9D-EA47-5228-B457CA6AA4A6}"/>
                </a:ext>
              </a:extLst>
            </p:cNvPr>
            <p:cNvGrpSpPr/>
            <p:nvPr/>
          </p:nvGrpSpPr>
          <p:grpSpPr>
            <a:xfrm>
              <a:off x="6096000" y="2911475"/>
              <a:ext cx="316800" cy="31750"/>
              <a:chOff x="6096000" y="2911475"/>
              <a:chExt cx="316800" cy="31750"/>
            </a:xfrm>
          </p:grpSpPr>
          <p:cxnSp>
            <p:nvCxnSpPr>
              <p:cNvPr id="26" name="Straight Connector 25">
                <a:extLst>
                  <a:ext uri="{FF2B5EF4-FFF2-40B4-BE49-F238E27FC236}">
                    <a16:creationId xmlns:a16="http://schemas.microsoft.com/office/drawing/2014/main" xmlns="" id="{CD260EA8-3A70-CD28-C1C8-8CE6C855AF99}"/>
                  </a:ext>
                </a:extLst>
              </p:cNvPr>
              <p:cNvCxnSpPr/>
              <p:nvPr/>
            </p:nvCxnSpPr>
            <p:spPr>
              <a:xfrm>
                <a:off x="6096000" y="2942276"/>
                <a:ext cx="3168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26">
                <a:extLst>
                  <a:ext uri="{FF2B5EF4-FFF2-40B4-BE49-F238E27FC236}">
                    <a16:creationId xmlns:a16="http://schemas.microsoft.com/office/drawing/2014/main" xmlns="" id="{E33BDD8A-42AA-484D-0E66-FBE0AC587EB4}"/>
                  </a:ext>
                </a:extLst>
              </p:cNvPr>
              <p:cNvCxnSpPr/>
              <p:nvPr/>
            </p:nvCxnSpPr>
            <p:spPr>
              <a:xfrm>
                <a:off x="6096000" y="2911475"/>
                <a:ext cx="0" cy="3175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>
                <a:extLst>
                  <a:ext uri="{FF2B5EF4-FFF2-40B4-BE49-F238E27FC236}">
                    <a16:creationId xmlns:a16="http://schemas.microsoft.com/office/drawing/2014/main" xmlns="" id="{0E2998F0-28A0-4810-B7B4-FC39E4CD10DC}"/>
                  </a:ext>
                </a:extLst>
              </p:cNvPr>
              <p:cNvCxnSpPr/>
              <p:nvPr/>
            </p:nvCxnSpPr>
            <p:spPr>
              <a:xfrm>
                <a:off x="6410325" y="2911475"/>
                <a:ext cx="0" cy="3175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9" name="Group 28">
            <a:extLst>
              <a:ext uri="{FF2B5EF4-FFF2-40B4-BE49-F238E27FC236}">
                <a16:creationId xmlns:a16="http://schemas.microsoft.com/office/drawing/2014/main" xmlns="" id="{1764B3CF-A53E-F7C6-9A8D-5A2C59632977}"/>
              </a:ext>
            </a:extLst>
          </p:cNvPr>
          <p:cNvGrpSpPr/>
          <p:nvPr/>
        </p:nvGrpSpPr>
        <p:grpSpPr>
          <a:xfrm>
            <a:off x="4645692" y="5016308"/>
            <a:ext cx="402481" cy="169277"/>
            <a:chOff x="6074038" y="2815446"/>
            <a:chExt cx="402481" cy="169277"/>
          </a:xfrm>
        </p:grpSpPr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xmlns="" id="{4275F658-7FDE-608D-4547-1226F6EACCFC}"/>
                </a:ext>
              </a:extLst>
            </p:cNvPr>
            <p:cNvSpPr txBox="1"/>
            <p:nvPr/>
          </p:nvSpPr>
          <p:spPr>
            <a:xfrm>
              <a:off x="6074038" y="2815446"/>
              <a:ext cx="40248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/>
                <a:t>200uM</a:t>
              </a:r>
            </a:p>
          </p:txBody>
        </p:sp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xmlns="" id="{7E80BE0E-BB4D-94DD-FB6B-B12211C98D28}"/>
                </a:ext>
              </a:extLst>
            </p:cNvPr>
            <p:cNvGrpSpPr/>
            <p:nvPr/>
          </p:nvGrpSpPr>
          <p:grpSpPr>
            <a:xfrm>
              <a:off x="6096000" y="2911475"/>
              <a:ext cx="316800" cy="31750"/>
              <a:chOff x="6096000" y="2911475"/>
              <a:chExt cx="316800" cy="31750"/>
            </a:xfrm>
          </p:grpSpPr>
          <p:cxnSp>
            <p:nvCxnSpPr>
              <p:cNvPr id="32" name="Straight Connector 31">
                <a:extLst>
                  <a:ext uri="{FF2B5EF4-FFF2-40B4-BE49-F238E27FC236}">
                    <a16:creationId xmlns:a16="http://schemas.microsoft.com/office/drawing/2014/main" xmlns="" id="{A2F61F6F-933B-595F-96D9-229EC3C4C3A7}"/>
                  </a:ext>
                </a:extLst>
              </p:cNvPr>
              <p:cNvCxnSpPr/>
              <p:nvPr/>
            </p:nvCxnSpPr>
            <p:spPr>
              <a:xfrm>
                <a:off x="6096000" y="2942276"/>
                <a:ext cx="3168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3" name="Straight Connector 32">
                <a:extLst>
                  <a:ext uri="{FF2B5EF4-FFF2-40B4-BE49-F238E27FC236}">
                    <a16:creationId xmlns:a16="http://schemas.microsoft.com/office/drawing/2014/main" xmlns="" id="{DF18BB56-36FD-B07E-6D82-BFFFC47DDACD}"/>
                  </a:ext>
                </a:extLst>
              </p:cNvPr>
              <p:cNvCxnSpPr/>
              <p:nvPr/>
            </p:nvCxnSpPr>
            <p:spPr>
              <a:xfrm>
                <a:off x="6096000" y="2911475"/>
                <a:ext cx="0" cy="3175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4" name="Straight Connector 33">
                <a:extLst>
                  <a:ext uri="{FF2B5EF4-FFF2-40B4-BE49-F238E27FC236}">
                    <a16:creationId xmlns:a16="http://schemas.microsoft.com/office/drawing/2014/main" xmlns="" id="{E912C039-5362-E72C-1844-42CAA8124973}"/>
                  </a:ext>
                </a:extLst>
              </p:cNvPr>
              <p:cNvCxnSpPr/>
              <p:nvPr/>
            </p:nvCxnSpPr>
            <p:spPr>
              <a:xfrm>
                <a:off x="6410325" y="2911475"/>
                <a:ext cx="0" cy="3175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5" name="Group 34">
            <a:extLst>
              <a:ext uri="{FF2B5EF4-FFF2-40B4-BE49-F238E27FC236}">
                <a16:creationId xmlns:a16="http://schemas.microsoft.com/office/drawing/2014/main" xmlns="" id="{9BA0C7CE-63D1-2465-18A1-3F6330250A98}"/>
              </a:ext>
            </a:extLst>
          </p:cNvPr>
          <p:cNvGrpSpPr/>
          <p:nvPr/>
        </p:nvGrpSpPr>
        <p:grpSpPr>
          <a:xfrm>
            <a:off x="6699974" y="4920279"/>
            <a:ext cx="402481" cy="169277"/>
            <a:chOff x="6074038" y="2815446"/>
            <a:chExt cx="402481" cy="169277"/>
          </a:xfrm>
        </p:grpSpPr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xmlns="" id="{3E2AC64F-EAD6-1514-6C36-6FA2D979C07A}"/>
                </a:ext>
              </a:extLst>
            </p:cNvPr>
            <p:cNvSpPr txBox="1"/>
            <p:nvPr/>
          </p:nvSpPr>
          <p:spPr>
            <a:xfrm>
              <a:off x="6074038" y="2815446"/>
              <a:ext cx="40248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/>
                <a:t>200uM</a:t>
              </a:r>
            </a:p>
          </p:txBody>
        </p:sp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xmlns="" id="{3BC15252-CB6D-B251-6C69-6085A4B0D977}"/>
                </a:ext>
              </a:extLst>
            </p:cNvPr>
            <p:cNvGrpSpPr/>
            <p:nvPr/>
          </p:nvGrpSpPr>
          <p:grpSpPr>
            <a:xfrm>
              <a:off x="6096000" y="2911475"/>
              <a:ext cx="316800" cy="31750"/>
              <a:chOff x="6096000" y="2911475"/>
              <a:chExt cx="316800" cy="31750"/>
            </a:xfrm>
          </p:grpSpPr>
          <p:cxnSp>
            <p:nvCxnSpPr>
              <p:cNvPr id="38" name="Straight Connector 37">
                <a:extLst>
                  <a:ext uri="{FF2B5EF4-FFF2-40B4-BE49-F238E27FC236}">
                    <a16:creationId xmlns:a16="http://schemas.microsoft.com/office/drawing/2014/main" xmlns="" id="{892ABCC8-7D36-6203-59DE-C7A0CE438D69}"/>
                  </a:ext>
                </a:extLst>
              </p:cNvPr>
              <p:cNvCxnSpPr/>
              <p:nvPr/>
            </p:nvCxnSpPr>
            <p:spPr>
              <a:xfrm>
                <a:off x="6096000" y="2942276"/>
                <a:ext cx="3168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9" name="Straight Connector 38">
                <a:extLst>
                  <a:ext uri="{FF2B5EF4-FFF2-40B4-BE49-F238E27FC236}">
                    <a16:creationId xmlns:a16="http://schemas.microsoft.com/office/drawing/2014/main" xmlns="" id="{9048403A-A8B8-71BC-49A1-936F4941F311}"/>
                  </a:ext>
                </a:extLst>
              </p:cNvPr>
              <p:cNvCxnSpPr/>
              <p:nvPr/>
            </p:nvCxnSpPr>
            <p:spPr>
              <a:xfrm>
                <a:off x="6096000" y="2911475"/>
                <a:ext cx="0" cy="3175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0" name="Straight Connector 39">
                <a:extLst>
                  <a:ext uri="{FF2B5EF4-FFF2-40B4-BE49-F238E27FC236}">
                    <a16:creationId xmlns:a16="http://schemas.microsoft.com/office/drawing/2014/main" xmlns="" id="{991DF3DC-F836-9A92-4F0A-3281B822B963}"/>
                  </a:ext>
                </a:extLst>
              </p:cNvPr>
              <p:cNvCxnSpPr/>
              <p:nvPr/>
            </p:nvCxnSpPr>
            <p:spPr>
              <a:xfrm>
                <a:off x="6410325" y="2911475"/>
                <a:ext cx="0" cy="3175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1" name="Group 40">
            <a:extLst>
              <a:ext uri="{FF2B5EF4-FFF2-40B4-BE49-F238E27FC236}">
                <a16:creationId xmlns:a16="http://schemas.microsoft.com/office/drawing/2014/main" xmlns="" id="{53F1A2BD-EE9A-C46C-FB60-FD924FAFE673}"/>
              </a:ext>
            </a:extLst>
          </p:cNvPr>
          <p:cNvGrpSpPr/>
          <p:nvPr/>
        </p:nvGrpSpPr>
        <p:grpSpPr>
          <a:xfrm>
            <a:off x="8211112" y="2845398"/>
            <a:ext cx="402481" cy="169277"/>
            <a:chOff x="6074038" y="2815446"/>
            <a:chExt cx="402481" cy="169277"/>
          </a:xfrm>
        </p:grpSpPr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xmlns="" id="{50FEB188-FB5C-48C1-3BEF-338F38862A01}"/>
                </a:ext>
              </a:extLst>
            </p:cNvPr>
            <p:cNvSpPr txBox="1"/>
            <p:nvPr/>
          </p:nvSpPr>
          <p:spPr>
            <a:xfrm>
              <a:off x="6074038" y="2815446"/>
              <a:ext cx="40248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/>
                <a:t>200uM</a:t>
              </a:r>
            </a:p>
          </p:txBody>
        </p:sp>
        <p:grpSp>
          <p:nvGrpSpPr>
            <p:cNvPr id="43" name="Group 42">
              <a:extLst>
                <a:ext uri="{FF2B5EF4-FFF2-40B4-BE49-F238E27FC236}">
                  <a16:creationId xmlns:a16="http://schemas.microsoft.com/office/drawing/2014/main" xmlns="" id="{078AF7E3-41A1-D58D-8C32-4AD12C8369BF}"/>
                </a:ext>
              </a:extLst>
            </p:cNvPr>
            <p:cNvGrpSpPr/>
            <p:nvPr/>
          </p:nvGrpSpPr>
          <p:grpSpPr>
            <a:xfrm>
              <a:off x="6096000" y="2911475"/>
              <a:ext cx="316800" cy="31750"/>
              <a:chOff x="6096000" y="2911475"/>
              <a:chExt cx="316800" cy="31750"/>
            </a:xfrm>
          </p:grpSpPr>
          <p:cxnSp>
            <p:nvCxnSpPr>
              <p:cNvPr id="44" name="Straight Connector 43">
                <a:extLst>
                  <a:ext uri="{FF2B5EF4-FFF2-40B4-BE49-F238E27FC236}">
                    <a16:creationId xmlns:a16="http://schemas.microsoft.com/office/drawing/2014/main" xmlns="" id="{2F5F51B4-A4AC-BC8A-82FB-69899B18E50A}"/>
                  </a:ext>
                </a:extLst>
              </p:cNvPr>
              <p:cNvCxnSpPr/>
              <p:nvPr/>
            </p:nvCxnSpPr>
            <p:spPr>
              <a:xfrm>
                <a:off x="6096000" y="2942276"/>
                <a:ext cx="3168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5" name="Straight Connector 44">
                <a:extLst>
                  <a:ext uri="{FF2B5EF4-FFF2-40B4-BE49-F238E27FC236}">
                    <a16:creationId xmlns:a16="http://schemas.microsoft.com/office/drawing/2014/main" xmlns="" id="{37B15B1B-2FCE-EE90-3999-34B6D482FD49}"/>
                  </a:ext>
                </a:extLst>
              </p:cNvPr>
              <p:cNvCxnSpPr/>
              <p:nvPr/>
            </p:nvCxnSpPr>
            <p:spPr>
              <a:xfrm>
                <a:off x="6096000" y="2911475"/>
                <a:ext cx="0" cy="3175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6" name="Straight Connector 45">
                <a:extLst>
                  <a:ext uri="{FF2B5EF4-FFF2-40B4-BE49-F238E27FC236}">
                    <a16:creationId xmlns:a16="http://schemas.microsoft.com/office/drawing/2014/main" xmlns="" id="{A5C3D3C5-843B-DB2B-E314-8A9F255704A1}"/>
                  </a:ext>
                </a:extLst>
              </p:cNvPr>
              <p:cNvCxnSpPr/>
              <p:nvPr/>
            </p:nvCxnSpPr>
            <p:spPr>
              <a:xfrm>
                <a:off x="6410325" y="2911475"/>
                <a:ext cx="0" cy="3175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47" name="Group 46">
            <a:extLst>
              <a:ext uri="{FF2B5EF4-FFF2-40B4-BE49-F238E27FC236}">
                <a16:creationId xmlns:a16="http://schemas.microsoft.com/office/drawing/2014/main" xmlns="" id="{6AC063C1-FA81-C138-7332-50123B3EF8CA}"/>
              </a:ext>
            </a:extLst>
          </p:cNvPr>
          <p:cNvGrpSpPr/>
          <p:nvPr/>
        </p:nvGrpSpPr>
        <p:grpSpPr>
          <a:xfrm>
            <a:off x="8582080" y="4920278"/>
            <a:ext cx="402481" cy="169277"/>
            <a:chOff x="6074038" y="2815446"/>
            <a:chExt cx="402481" cy="169277"/>
          </a:xfrm>
        </p:grpSpPr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xmlns="" id="{F6C66AD6-31BE-6D2D-97DD-21D2E774F2E1}"/>
                </a:ext>
              </a:extLst>
            </p:cNvPr>
            <p:cNvSpPr txBox="1"/>
            <p:nvPr/>
          </p:nvSpPr>
          <p:spPr>
            <a:xfrm>
              <a:off x="6074038" y="2815446"/>
              <a:ext cx="402481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500" dirty="0"/>
                <a:t>200uM</a:t>
              </a:r>
            </a:p>
          </p:txBody>
        </p:sp>
        <p:grpSp>
          <p:nvGrpSpPr>
            <p:cNvPr id="49" name="Group 48">
              <a:extLst>
                <a:ext uri="{FF2B5EF4-FFF2-40B4-BE49-F238E27FC236}">
                  <a16:creationId xmlns:a16="http://schemas.microsoft.com/office/drawing/2014/main" xmlns="" id="{47C1E0BB-45DB-FDA0-427E-2A1DB13DFA1C}"/>
                </a:ext>
              </a:extLst>
            </p:cNvPr>
            <p:cNvGrpSpPr/>
            <p:nvPr/>
          </p:nvGrpSpPr>
          <p:grpSpPr>
            <a:xfrm>
              <a:off x="6096000" y="2911475"/>
              <a:ext cx="316800" cy="31750"/>
              <a:chOff x="6096000" y="2911475"/>
              <a:chExt cx="316800" cy="31750"/>
            </a:xfrm>
          </p:grpSpPr>
          <p:cxnSp>
            <p:nvCxnSpPr>
              <p:cNvPr id="50" name="Straight Connector 49">
                <a:extLst>
                  <a:ext uri="{FF2B5EF4-FFF2-40B4-BE49-F238E27FC236}">
                    <a16:creationId xmlns:a16="http://schemas.microsoft.com/office/drawing/2014/main" xmlns="" id="{B950A944-CA20-788C-4BCB-71A955981B65}"/>
                  </a:ext>
                </a:extLst>
              </p:cNvPr>
              <p:cNvCxnSpPr/>
              <p:nvPr/>
            </p:nvCxnSpPr>
            <p:spPr>
              <a:xfrm>
                <a:off x="6096000" y="2942276"/>
                <a:ext cx="316800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1" name="Straight Connector 50">
                <a:extLst>
                  <a:ext uri="{FF2B5EF4-FFF2-40B4-BE49-F238E27FC236}">
                    <a16:creationId xmlns:a16="http://schemas.microsoft.com/office/drawing/2014/main" xmlns="" id="{90C5CC10-3A46-1CB8-A588-E01CCF13FCB3}"/>
                  </a:ext>
                </a:extLst>
              </p:cNvPr>
              <p:cNvCxnSpPr/>
              <p:nvPr/>
            </p:nvCxnSpPr>
            <p:spPr>
              <a:xfrm>
                <a:off x="6096000" y="2911475"/>
                <a:ext cx="0" cy="3175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2" name="Straight Connector 51">
                <a:extLst>
                  <a:ext uri="{FF2B5EF4-FFF2-40B4-BE49-F238E27FC236}">
                    <a16:creationId xmlns:a16="http://schemas.microsoft.com/office/drawing/2014/main" xmlns="" id="{8AC94D7B-1854-0C7E-C4A5-686D441B71C4}"/>
                  </a:ext>
                </a:extLst>
              </p:cNvPr>
              <p:cNvCxnSpPr/>
              <p:nvPr/>
            </p:nvCxnSpPr>
            <p:spPr>
              <a:xfrm>
                <a:off x="6410325" y="2911475"/>
                <a:ext cx="0" cy="3175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32324399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686ACBF7-90CC-C2E0-6981-85BB87FF3D4F}"/>
              </a:ext>
            </a:extLst>
          </p:cNvPr>
          <p:cNvSpPr txBox="1"/>
          <p:nvPr/>
        </p:nvSpPr>
        <p:spPr>
          <a:xfrm>
            <a:off x="130338" y="33697"/>
            <a:ext cx="1174023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Kaplan-Meier overall survival curve in primary-advanced (III-IV) LGSOC patients (n=146) with p16 immunohistochemistry tumor expression. </a:t>
            </a:r>
            <a:r>
              <a:rPr kumimoji="0" lang="en-US" sz="120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A) Overall survival curves of normal vs abnormal absent vs abnormal block p16 expression in (p-value = 0.018). B) Overall survival curves of normal vs abnormal block p16 expression in tumors (p = 0.109)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8668F59F-2A92-DCCF-C01F-4F7FDCA9302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76986" y="1186580"/>
            <a:ext cx="4893342" cy="4521569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xmlns="" id="{EBFF06CE-B822-5684-9568-20711291290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36260" y="1048080"/>
            <a:ext cx="4893342" cy="4306539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A5DEF275-6DE7-C385-B420-42E066D7286A}"/>
              </a:ext>
            </a:extLst>
          </p:cNvPr>
          <p:cNvSpPr txBox="1"/>
          <p:nvPr/>
        </p:nvSpPr>
        <p:spPr>
          <a:xfrm>
            <a:off x="674902" y="1048080"/>
            <a:ext cx="574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18D89FF5-E160-D232-E1EC-3D6C91656CB2}"/>
              </a:ext>
            </a:extLst>
          </p:cNvPr>
          <p:cNvSpPr txBox="1"/>
          <p:nvPr/>
        </p:nvSpPr>
        <p:spPr>
          <a:xfrm>
            <a:off x="6336260" y="1048080"/>
            <a:ext cx="574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14720947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xmlns="" id="{A781010D-FBAC-C9B0-DBC4-280351B5406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0168B132-FE58-EE21-C3B9-6107A80B5B05}"/>
              </a:ext>
            </a:extLst>
          </p:cNvPr>
          <p:cNvSpPr txBox="1"/>
          <p:nvPr/>
        </p:nvSpPr>
        <p:spPr>
          <a:xfrm>
            <a:off x="305789" y="160309"/>
            <a:ext cx="1139140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nsitivity of 12 patient derived LGSOC cell lines to CDK4/6 inhibitors (investigative – FDA approved) following 0.1uM treatment (72hrs). IOSE-523 (normal ovary) serves as a toxicity control. Viability denoted through robust Z-score with &lt; -2 indicating cytotoxicity. LGSOC cytotoxicity indicates percentage of all LGSOC cell lines in which a robust Z-score of &lt; -2 was achieved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27734F7A-EDC3-94FC-6BC1-D7C862B27A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1249557"/>
            <a:ext cx="7964510" cy="46459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38822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8C179122-E567-92AF-62FB-A135D7648D83}"/>
              </a:ext>
            </a:extLst>
          </p:cNvPr>
          <p:cNvSpPr txBox="1"/>
          <p:nvPr/>
        </p:nvSpPr>
        <p:spPr>
          <a:xfrm>
            <a:off x="472829" y="397418"/>
            <a:ext cx="1124634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Characterization of newly derived LGSOC cell line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of previously described biomarkers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K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sistance (EGFR and PKC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 newly-derived LGSOC cell lines (VOA14202*, VOA13738#, VOA10841~). (*)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RA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(#)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F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(~)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RA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</p:txBody>
      </p:sp>
      <p:grpSp>
        <p:nvGrpSpPr>
          <p:cNvPr id="53" name="Group 52">
            <a:extLst>
              <a:ext uri="{FF2B5EF4-FFF2-40B4-BE49-F238E27FC236}">
                <a16:creationId xmlns:a16="http://schemas.microsoft.com/office/drawing/2014/main" xmlns="" id="{0A65E739-ABFE-D0BB-8F75-8EE5467E3A89}"/>
              </a:ext>
            </a:extLst>
          </p:cNvPr>
          <p:cNvGrpSpPr/>
          <p:nvPr/>
        </p:nvGrpSpPr>
        <p:grpSpPr>
          <a:xfrm>
            <a:off x="5160560" y="2653749"/>
            <a:ext cx="4298923" cy="2468076"/>
            <a:chOff x="5160560" y="2653749"/>
            <a:chExt cx="4298923" cy="2468076"/>
          </a:xfrm>
        </p:grpSpPr>
        <p:sp>
          <p:nvSpPr>
            <p:cNvPr id="34" name="Text Box 476">
              <a:extLst>
                <a:ext uri="{FF2B5EF4-FFF2-40B4-BE49-F238E27FC236}">
                  <a16:creationId xmlns:a16="http://schemas.microsoft.com/office/drawing/2014/main" xmlns="" id="{DB3F934A-9BC5-0E6D-3FE4-D5150FE15E6B}"/>
                </a:ext>
              </a:extLst>
            </p:cNvPr>
            <p:cNvSpPr txBox="1"/>
            <p:nvPr/>
          </p:nvSpPr>
          <p:spPr>
            <a:xfrm>
              <a:off x="8455789" y="3681686"/>
              <a:ext cx="825574" cy="372247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PKC</a:t>
              </a:r>
              <a:r>
                <a:rPr lang="el-G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endParaRPr lang="en-CA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endParaRPr>
            </a:p>
          </p:txBody>
        </p:sp>
        <p:sp>
          <p:nvSpPr>
            <p:cNvPr id="36" name="Text Box 479">
              <a:extLst>
                <a:ext uri="{FF2B5EF4-FFF2-40B4-BE49-F238E27FC236}">
                  <a16:creationId xmlns:a16="http://schemas.microsoft.com/office/drawing/2014/main" xmlns="" id="{1DB33772-789D-07F3-0574-EEE220DD07DE}"/>
                </a:ext>
              </a:extLst>
            </p:cNvPr>
            <p:cNvSpPr txBox="1"/>
            <p:nvPr/>
          </p:nvSpPr>
          <p:spPr>
            <a:xfrm>
              <a:off x="8455789" y="4207062"/>
              <a:ext cx="1003694" cy="369104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sz="1200">
                  <a:solidFill>
                    <a:srgbClr val="000000"/>
                  </a:solidFill>
                  <a:latin typeface="Times New Roman" panose="02020603050405020304" pitchFamily="18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EGFR</a:t>
              </a:r>
              <a:endParaRPr lang="en-CA" sz="120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endParaRPr>
            </a:p>
          </p:txBody>
        </p:sp>
        <p:sp>
          <p:nvSpPr>
            <p:cNvPr id="39" name="Text Box 480">
              <a:extLst>
                <a:ext uri="{FF2B5EF4-FFF2-40B4-BE49-F238E27FC236}">
                  <a16:creationId xmlns:a16="http://schemas.microsoft.com/office/drawing/2014/main" xmlns="" id="{270F6EDF-D273-0C39-02C6-34FDFAEEBDC9}"/>
                </a:ext>
              </a:extLst>
            </p:cNvPr>
            <p:cNvSpPr txBox="1"/>
            <p:nvPr/>
          </p:nvSpPr>
          <p:spPr>
            <a:xfrm>
              <a:off x="8455789" y="4672860"/>
              <a:ext cx="781837" cy="314442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sz="1200" dirty="0">
                  <a:solidFill>
                    <a:srgbClr val="000000"/>
                  </a:solidFill>
                  <a:latin typeface="Times New Roman" panose="02020603050405020304" pitchFamily="18" charset="0"/>
                  <a:ea typeface="MS Mincho" panose="02020609040205080304" pitchFamily="49" charset="-128"/>
                  <a:cs typeface="Times New Roman" panose="02020603050405020304" pitchFamily="18" charset="0"/>
                </a:rPr>
                <a:t>Vinculin</a:t>
              </a:r>
              <a:endParaRPr lang="en-CA" sz="12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endParaRPr>
            </a:p>
          </p:txBody>
        </p:sp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xmlns="" id="{C3F66811-EF38-5D5A-2277-6899D3962C98}"/>
                </a:ext>
              </a:extLst>
            </p:cNvPr>
            <p:cNvGrpSpPr/>
            <p:nvPr/>
          </p:nvGrpSpPr>
          <p:grpSpPr>
            <a:xfrm>
              <a:off x="5376782" y="2653749"/>
              <a:ext cx="3016511" cy="951884"/>
              <a:chOff x="5535808" y="1659837"/>
              <a:chExt cx="3016511" cy="951884"/>
            </a:xfrm>
          </p:grpSpPr>
          <p:sp>
            <p:nvSpPr>
              <p:cNvPr id="40" name="TextBox 17">
                <a:extLst>
                  <a:ext uri="{FF2B5EF4-FFF2-40B4-BE49-F238E27FC236}">
                    <a16:creationId xmlns:a16="http://schemas.microsoft.com/office/drawing/2014/main" xmlns="" id="{DC591655-7559-7C96-7A64-169CCCB4307F}"/>
                  </a:ext>
                </a:extLst>
              </p:cNvPr>
              <p:cNvSpPr txBox="1"/>
              <p:nvPr/>
            </p:nvSpPr>
            <p:spPr>
              <a:xfrm rot="16200000">
                <a:off x="7624401" y="2087896"/>
                <a:ext cx="792861" cy="254788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square" lIns="38098" tIns="38098" rIns="38098" bIns="38098" numCol="1" anchor="t">
                <a:noAutofit/>
              </a:bodyPr>
              <a:lstStyle/>
              <a:p>
                <a:pPr hangingPunct="0"/>
                <a:r>
                  <a:rPr lang="en-CA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Helvetica Neue" panose="02000503000000020004" pitchFamily="2" charset="0"/>
                    <a:cs typeface="Times New Roman" panose="02020603050405020304" pitchFamily="18" charset="0"/>
                  </a:rPr>
                  <a:t>VOA6406</a:t>
                </a:r>
                <a:endParaRPr lang="en-CA" sz="1200" dirty="0">
                  <a:latin typeface="Times New Roman" panose="02020603050405020304" pitchFamily="18" charset="0"/>
                  <a:ea typeface="MS Mincho" panose="02020609040205080304" pitchFamily="49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TextBox 17">
                <a:extLst>
                  <a:ext uri="{FF2B5EF4-FFF2-40B4-BE49-F238E27FC236}">
                    <a16:creationId xmlns:a16="http://schemas.microsoft.com/office/drawing/2014/main" xmlns="" id="{144076A5-5FF0-E286-7518-0A9B634A0D35}"/>
                  </a:ext>
                </a:extLst>
              </p:cNvPr>
              <p:cNvSpPr txBox="1"/>
              <p:nvPr/>
            </p:nvSpPr>
            <p:spPr>
              <a:xfrm rot="16200000">
                <a:off x="7296758" y="2087896"/>
                <a:ext cx="792861" cy="254788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square" lIns="38098" tIns="38098" rIns="38098" bIns="38098" numCol="1" anchor="t">
                <a:noAutofit/>
              </a:bodyPr>
              <a:lstStyle/>
              <a:p>
                <a:pPr hangingPunct="0"/>
                <a:r>
                  <a:rPr lang="en-CA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Helvetica Neue" panose="02000503000000020004" pitchFamily="2" charset="0"/>
                    <a:cs typeface="Times New Roman" panose="02020603050405020304" pitchFamily="18" charset="0"/>
                  </a:rPr>
                  <a:t>VOA4627</a:t>
                </a:r>
                <a:endParaRPr lang="en-CA" sz="1200" dirty="0">
                  <a:latin typeface="Times New Roman" panose="02020603050405020304" pitchFamily="18" charset="0"/>
                  <a:ea typeface="MS Mincho" panose="02020609040205080304" pitchFamily="49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xmlns="" id="{3C102814-DE11-C243-13F3-8FB66586F9EA}"/>
                  </a:ext>
                </a:extLst>
              </p:cNvPr>
              <p:cNvSpPr txBox="1"/>
              <p:nvPr/>
            </p:nvSpPr>
            <p:spPr>
              <a:xfrm rot="16200000">
                <a:off x="6947274" y="2087898"/>
                <a:ext cx="792858" cy="254788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square" lIns="38098" tIns="38098" rIns="38098" bIns="38098" numCol="1" anchor="t">
                <a:noAutofit/>
              </a:bodyPr>
              <a:lstStyle/>
              <a:p>
                <a:pPr hangingPunct="0"/>
                <a:r>
                  <a:rPr lang="en-CA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Helvetica Neue" panose="02000503000000020004" pitchFamily="2" charset="0"/>
                    <a:cs typeface="Times New Roman" panose="02020603050405020304" pitchFamily="18" charset="0"/>
                  </a:rPr>
                  <a:t>VOA3723</a:t>
                </a:r>
                <a:endParaRPr lang="en-CA" sz="1200" dirty="0">
                  <a:latin typeface="Times New Roman" panose="02020603050405020304" pitchFamily="18" charset="0"/>
                  <a:ea typeface="MS Mincho" panose="02020609040205080304" pitchFamily="49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TextBox 17">
                <a:extLst>
                  <a:ext uri="{FF2B5EF4-FFF2-40B4-BE49-F238E27FC236}">
                    <a16:creationId xmlns:a16="http://schemas.microsoft.com/office/drawing/2014/main" xmlns="" id="{A883F314-E64E-8BCE-49DA-B16B773FDA5A}"/>
                  </a:ext>
                </a:extLst>
              </p:cNvPr>
              <p:cNvSpPr txBox="1"/>
              <p:nvPr/>
            </p:nvSpPr>
            <p:spPr>
              <a:xfrm rot="16200000">
                <a:off x="6619558" y="2088040"/>
                <a:ext cx="792574" cy="254788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square" lIns="38098" tIns="38098" rIns="38098" bIns="38098" numCol="1" anchor="t">
                <a:noAutofit/>
              </a:bodyPr>
              <a:lstStyle/>
              <a:p>
                <a:pPr hangingPunct="0"/>
                <a:r>
                  <a:rPr lang="en-CA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Helvetica Neue" panose="02000503000000020004" pitchFamily="2" charset="0"/>
                    <a:cs typeface="Times New Roman" panose="02020603050405020304" pitchFamily="18" charset="0"/>
                  </a:rPr>
                  <a:t>VOA8862</a:t>
                </a:r>
                <a:endParaRPr lang="en-CA" sz="1200" dirty="0">
                  <a:latin typeface="Times New Roman" panose="02020603050405020304" pitchFamily="18" charset="0"/>
                  <a:ea typeface="MS Mincho" panose="02020609040205080304" pitchFamily="49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TextBox 17">
                <a:extLst>
                  <a:ext uri="{FF2B5EF4-FFF2-40B4-BE49-F238E27FC236}">
                    <a16:creationId xmlns:a16="http://schemas.microsoft.com/office/drawing/2014/main" xmlns="" id="{78BC5434-E93E-5C7F-3F78-4FBEE8969CC8}"/>
                  </a:ext>
                </a:extLst>
              </p:cNvPr>
              <p:cNvSpPr txBox="1"/>
              <p:nvPr/>
            </p:nvSpPr>
            <p:spPr>
              <a:xfrm rot="16200000">
                <a:off x="6291915" y="2088040"/>
                <a:ext cx="792574" cy="254788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square" lIns="38098" tIns="38098" rIns="38098" bIns="38098" numCol="1" anchor="t">
                <a:noAutofit/>
              </a:bodyPr>
              <a:lstStyle/>
              <a:p>
                <a:pPr hangingPunct="0"/>
                <a:r>
                  <a:rPr lang="en-CA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Helvetica Neue" panose="02000503000000020004" pitchFamily="2" charset="0"/>
                    <a:cs typeface="Times New Roman" panose="02020603050405020304" pitchFamily="18" charset="0"/>
                  </a:rPr>
                  <a:t>VOA9164</a:t>
                </a:r>
                <a:endParaRPr lang="en-CA" sz="1200" dirty="0">
                  <a:latin typeface="Times New Roman" panose="02020603050405020304" pitchFamily="18" charset="0"/>
                  <a:ea typeface="MS Mincho" panose="02020609040205080304" pitchFamily="49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TextBox 17">
                <a:extLst>
                  <a:ext uri="{FF2B5EF4-FFF2-40B4-BE49-F238E27FC236}">
                    <a16:creationId xmlns:a16="http://schemas.microsoft.com/office/drawing/2014/main" xmlns="" id="{F6C0B509-3A28-3A23-B0F5-C8E62FBC2CE8}"/>
                  </a:ext>
                </a:extLst>
              </p:cNvPr>
              <p:cNvSpPr txBox="1"/>
              <p:nvPr/>
            </p:nvSpPr>
            <p:spPr>
              <a:xfrm rot="16200000">
                <a:off x="5862989" y="2008385"/>
                <a:ext cx="951884" cy="254788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square" lIns="38098" tIns="38098" rIns="38098" bIns="38098" numCol="1" anchor="t">
                <a:noAutofit/>
              </a:bodyPr>
              <a:lstStyle/>
              <a:p>
                <a:pPr hangingPunct="0"/>
                <a:r>
                  <a:rPr lang="en-CA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Helvetica Neue" panose="02000503000000020004" pitchFamily="2" charset="0"/>
                    <a:cs typeface="Times New Roman" panose="02020603050405020304" pitchFamily="18" charset="0"/>
                  </a:rPr>
                  <a:t>VOA1312</a:t>
                </a:r>
                <a:endParaRPr lang="en-CA" sz="1200" dirty="0">
                  <a:latin typeface="Times New Roman" panose="02020603050405020304" pitchFamily="18" charset="0"/>
                  <a:ea typeface="MS Mincho" panose="02020609040205080304" pitchFamily="49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TextBox 17">
                <a:extLst>
                  <a:ext uri="{FF2B5EF4-FFF2-40B4-BE49-F238E27FC236}">
                    <a16:creationId xmlns:a16="http://schemas.microsoft.com/office/drawing/2014/main" xmlns="" id="{32E17B02-43BA-B113-4549-B3F02E0D81DB}"/>
                  </a:ext>
                </a:extLst>
              </p:cNvPr>
              <p:cNvSpPr txBox="1"/>
              <p:nvPr/>
            </p:nvSpPr>
            <p:spPr>
              <a:xfrm rot="16200000">
                <a:off x="5593016" y="2087898"/>
                <a:ext cx="792858" cy="254788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square" lIns="38098" tIns="38098" rIns="38098" bIns="38098" numCol="1" anchor="t">
                <a:noAutofit/>
              </a:bodyPr>
              <a:lstStyle/>
              <a:p>
                <a:pPr hangingPunct="0"/>
                <a:r>
                  <a:rPr lang="en-CA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Helvetica Neue" panose="02000503000000020004" pitchFamily="2" charset="0"/>
                    <a:cs typeface="Times New Roman" panose="02020603050405020304" pitchFamily="18" charset="0"/>
                  </a:rPr>
                  <a:t>iOvCa241</a:t>
                </a:r>
                <a:endParaRPr lang="en-CA" sz="1200" dirty="0">
                  <a:latin typeface="Times New Roman" panose="02020603050405020304" pitchFamily="18" charset="0"/>
                  <a:ea typeface="MS Mincho" panose="02020609040205080304" pitchFamily="49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47" name="TextBox 17">
                <a:extLst>
                  <a:ext uri="{FF2B5EF4-FFF2-40B4-BE49-F238E27FC236}">
                    <a16:creationId xmlns:a16="http://schemas.microsoft.com/office/drawing/2014/main" xmlns="" id="{307D7165-C34E-A708-0B34-5A4608655B43}"/>
                  </a:ext>
                </a:extLst>
              </p:cNvPr>
              <p:cNvSpPr txBox="1"/>
              <p:nvPr/>
            </p:nvSpPr>
            <p:spPr>
              <a:xfrm rot="16200000">
                <a:off x="8028494" y="2087896"/>
                <a:ext cx="792862" cy="254788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square" lIns="38098" tIns="38098" rIns="38098" bIns="38098" numCol="1" anchor="t">
                <a:noAutofit/>
              </a:bodyPr>
              <a:lstStyle/>
              <a:p>
                <a:pPr hangingPunct="0"/>
                <a:r>
                  <a:rPr lang="en-CA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Helvetica Neue" panose="02000503000000020004" pitchFamily="2" charset="0"/>
                    <a:cs typeface="Times New Roman" panose="02020603050405020304" pitchFamily="18" charset="0"/>
                  </a:rPr>
                  <a:t>VOA3993</a:t>
                </a:r>
                <a:endParaRPr lang="en-CA" sz="1200" dirty="0">
                  <a:latin typeface="Times New Roman" panose="02020603050405020304" pitchFamily="18" charset="0"/>
                  <a:ea typeface="MS Mincho" panose="02020609040205080304" pitchFamily="49" charset="-128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TextBox 17">
                <a:extLst>
                  <a:ext uri="{FF2B5EF4-FFF2-40B4-BE49-F238E27FC236}">
                    <a16:creationId xmlns:a16="http://schemas.microsoft.com/office/drawing/2014/main" xmlns="" id="{9B29DC32-2141-938A-FCB7-2566EBB70EA1}"/>
                  </a:ext>
                </a:extLst>
              </p:cNvPr>
              <p:cNvSpPr txBox="1"/>
              <p:nvPr/>
            </p:nvSpPr>
            <p:spPr>
              <a:xfrm rot="16200000">
                <a:off x="5193563" y="2014688"/>
                <a:ext cx="939277" cy="254788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val="1"/>
                </a:ext>
              </a:extLst>
            </p:spPr>
            <p:txBody>
              <a:bodyPr wrap="square" lIns="38098" tIns="38098" rIns="38098" bIns="38098" numCol="1" anchor="t">
                <a:noAutofit/>
              </a:bodyPr>
              <a:lstStyle/>
              <a:p>
                <a:pPr hangingPunct="0"/>
                <a:r>
                  <a:rPr lang="en-CA" sz="1200" dirty="0">
                    <a:solidFill>
                      <a:srgbClr val="000000"/>
                    </a:solidFill>
                    <a:latin typeface="Times New Roman" panose="02020603050405020304" pitchFamily="18" charset="0"/>
                    <a:ea typeface="Helvetica Neue" panose="02000503000000020004" pitchFamily="2" charset="0"/>
                    <a:cs typeface="Times New Roman" panose="02020603050405020304" pitchFamily="18" charset="0"/>
                  </a:rPr>
                  <a:t>VOA10841~</a:t>
                </a:r>
                <a:endParaRPr lang="en-CA" sz="1200" dirty="0">
                  <a:latin typeface="Times New Roman" panose="02020603050405020304" pitchFamily="18" charset="0"/>
                  <a:ea typeface="MS Mincho" panose="02020609040205080304" pitchFamily="49" charset="-128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xmlns="" id="{3D3CE3AD-0F6F-CB15-377A-963D1FC6FA11}"/>
                </a:ext>
              </a:extLst>
            </p:cNvPr>
            <p:cNvGrpSpPr/>
            <p:nvPr/>
          </p:nvGrpSpPr>
          <p:grpSpPr>
            <a:xfrm>
              <a:off x="5160560" y="3619704"/>
              <a:ext cx="3308985" cy="1502121"/>
              <a:chOff x="1933114" y="2124221"/>
              <a:chExt cx="4995883" cy="1783444"/>
            </a:xfrm>
          </p:grpSpPr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xmlns="" id="{1BF8F7B2-9985-4641-EB91-61D965B310F2}"/>
                  </a:ext>
                </a:extLst>
              </p:cNvPr>
              <p:cNvSpPr txBox="1"/>
              <p:nvPr/>
            </p:nvSpPr>
            <p:spPr>
              <a:xfrm rot="16200000">
                <a:off x="2932164" y="3064553"/>
                <a:ext cx="1055097" cy="61318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lnSpc>
                    <a:spcPct val="150000"/>
                  </a:lnSpc>
                </a:pPr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OA10841**</a:t>
                </a:r>
              </a:p>
              <a:p>
                <a:pPr>
                  <a:lnSpc>
                    <a:spcPct val="150000"/>
                  </a:lnSpc>
                </a:pPr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OvCa241**</a:t>
                </a:r>
              </a:p>
            </p:txBody>
          </p:sp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xmlns="" id="{25F8A592-BDBA-9DA5-8587-AE71EBADB08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t="16412" r="1248" b="48355"/>
              <a:stretch/>
            </p:blipFill>
            <p:spPr>
              <a:xfrm>
                <a:off x="1953883" y="2124221"/>
                <a:ext cx="4975114" cy="1189644"/>
              </a:xfrm>
              <a:prstGeom prst="rect">
                <a:avLst/>
              </a:prstGeom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xmlns="" id="{E4EC4DD1-D5EB-0DAF-002E-175119B4C42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t="82207" r="1248" b="-621"/>
              <a:stretch/>
            </p:blipFill>
            <p:spPr>
              <a:xfrm>
                <a:off x="1933114" y="3285914"/>
                <a:ext cx="4975114" cy="621751"/>
              </a:xfrm>
              <a:prstGeom prst="rect">
                <a:avLst/>
              </a:prstGeom>
            </p:spPr>
          </p:pic>
        </p:grpSp>
      </p:grpSp>
      <p:grpSp>
        <p:nvGrpSpPr>
          <p:cNvPr id="52" name="Group 51">
            <a:extLst>
              <a:ext uri="{FF2B5EF4-FFF2-40B4-BE49-F238E27FC236}">
                <a16:creationId xmlns:a16="http://schemas.microsoft.com/office/drawing/2014/main" xmlns="" id="{30ADE077-B33B-513B-1714-A419DBD54D00}"/>
              </a:ext>
            </a:extLst>
          </p:cNvPr>
          <p:cNvGrpSpPr/>
          <p:nvPr/>
        </p:nvGrpSpPr>
        <p:grpSpPr>
          <a:xfrm>
            <a:off x="2028540" y="1115119"/>
            <a:ext cx="2254757" cy="3941065"/>
            <a:chOff x="1511705" y="1115119"/>
            <a:chExt cx="2254757" cy="3941065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xmlns="" id="{3917BA9D-AAF1-F3FE-2F8F-02969E83306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grayscl/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aturation sat="66000"/>
                      </a14:imgEffect>
                    </a14:imgLayer>
                  </a14:imgProps>
                </a:ext>
              </a:extLst>
            </a:blip>
            <a:srcRect l="64224" t="-881" r="2397" b="5785"/>
            <a:stretch/>
          </p:blipFill>
          <p:spPr>
            <a:xfrm>
              <a:off x="1511705" y="4732184"/>
              <a:ext cx="1443919" cy="324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xmlns="" id="{F9B29D73-4591-862E-3604-09A2831AA20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grayscl/>
            </a:blip>
            <a:srcRect l="63673" t="-54" r="500" b="14163"/>
            <a:stretch/>
          </p:blipFill>
          <p:spPr>
            <a:xfrm>
              <a:off x="1511705" y="3932179"/>
              <a:ext cx="1443913" cy="286625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xmlns="" id="{608512D3-0E5C-DEB7-1174-F61B523AF81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grayscl/>
            </a:blip>
            <a:srcRect l="22988" t="-2612" b="13148"/>
            <a:stretch/>
          </p:blipFill>
          <p:spPr>
            <a:xfrm>
              <a:off x="1511705" y="4282542"/>
              <a:ext cx="1443919" cy="36933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xmlns="" id="{8F7E890E-3C8D-53E8-0349-C8D6AC03EFA7}"/>
                </a:ext>
              </a:extLst>
            </p:cNvPr>
            <p:cNvSpPr txBox="1"/>
            <p:nvPr/>
          </p:nvSpPr>
          <p:spPr>
            <a:xfrm>
              <a:off x="2961859" y="4308995"/>
              <a:ext cx="6744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GFR</a:t>
              </a:r>
              <a:endParaRPr lang="en-CA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xmlns="" id="{6BF2F2BB-1D34-DDB2-6F48-45C4A4E1C435}"/>
                </a:ext>
              </a:extLst>
            </p:cNvPr>
            <p:cNvSpPr txBox="1"/>
            <p:nvPr/>
          </p:nvSpPr>
          <p:spPr>
            <a:xfrm>
              <a:off x="2961859" y="4742591"/>
              <a:ext cx="80460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Vinculin </a:t>
              </a:r>
              <a:endParaRPr lang="en-CA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xmlns="" id="{B74B0456-0160-0333-9B1E-D489FA306AA3}"/>
                </a:ext>
              </a:extLst>
            </p:cNvPr>
            <p:cNvGrpSpPr/>
            <p:nvPr/>
          </p:nvGrpSpPr>
          <p:grpSpPr>
            <a:xfrm>
              <a:off x="1568386" y="1115119"/>
              <a:ext cx="1289148" cy="2801788"/>
              <a:chOff x="8471184" y="-579887"/>
              <a:chExt cx="1289148" cy="2801788"/>
            </a:xfrm>
          </p:grpSpPr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xmlns="" id="{431B71D8-A2EB-5CFA-33B5-76A6453EC89D}"/>
                  </a:ext>
                </a:extLst>
              </p:cNvPr>
              <p:cNvSpPr txBox="1"/>
              <p:nvPr/>
            </p:nvSpPr>
            <p:spPr>
              <a:xfrm rot="16200000">
                <a:off x="7968751" y="1442468"/>
                <a:ext cx="128186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OA14202*</a:t>
                </a:r>
                <a:endParaRPr lang="en-CA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xmlns="" id="{645B21DF-8E2C-C879-5343-1B97778009E4}"/>
                  </a:ext>
                </a:extLst>
              </p:cNvPr>
              <p:cNvSpPr txBox="1"/>
              <p:nvPr/>
            </p:nvSpPr>
            <p:spPr>
              <a:xfrm rot="16200000">
                <a:off x="8360928" y="1497847"/>
                <a:ext cx="117110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OA13738# 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xmlns="" id="{89C82040-142D-921F-F463-8B20C7828529}"/>
                  </a:ext>
                </a:extLst>
              </p:cNvPr>
              <p:cNvSpPr txBox="1"/>
              <p:nvPr/>
            </p:nvSpPr>
            <p:spPr>
              <a:xfrm rot="16200000">
                <a:off x="8114596" y="898446"/>
                <a:ext cx="234088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OA3723 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xmlns="" id="{5707C31A-13D4-1DD2-F479-6408EEB56447}"/>
                  </a:ext>
                </a:extLst>
              </p:cNvPr>
              <p:cNvSpPr txBox="1"/>
              <p:nvPr/>
            </p:nvSpPr>
            <p:spPr>
              <a:xfrm rot="16200000">
                <a:off x="8227123" y="676323"/>
                <a:ext cx="278942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OvCa241 </a:t>
                </a:r>
              </a:p>
            </p:txBody>
          </p:sp>
        </p:grp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xmlns="" id="{CCB881C6-5216-677B-CBF5-2318FD64A2D2}"/>
                </a:ext>
              </a:extLst>
            </p:cNvPr>
            <p:cNvSpPr txBox="1"/>
            <p:nvPr/>
          </p:nvSpPr>
          <p:spPr>
            <a:xfrm>
              <a:off x="2961859" y="3938897"/>
              <a:ext cx="6744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KC</a:t>
              </a:r>
              <a:r>
                <a:rPr lang="el-G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 </a:t>
              </a:r>
              <a:endParaRPr lang="en-CA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285293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583C5FA5-3599-8822-A6C5-AE114C846CC7}"/>
              </a:ext>
            </a:extLst>
          </p:cNvPr>
          <p:cNvSpPr txBox="1"/>
          <p:nvPr/>
        </p:nvSpPr>
        <p:spPr>
          <a:xfrm>
            <a:off x="444973" y="401213"/>
            <a:ext cx="11302054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CA" sz="1200" b="1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Figure S5. Drug synergism analysis of all PLB and TRA treatment combinations in LGSOC cell lines. </a:t>
            </a:r>
            <a:r>
              <a:rPr lang="en-CA" sz="12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ombination index (CI) of 90h PLB and TRA treatments in LGSOC cell lines (A) and acquired drug-resistant cell line derivatives (B). CI values  &lt;1.0 indicate synergistic drug effects, and CI &gt;1.0 indicate antagonistic drug effects. 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xmlns="" id="{C3CEC331-480D-3B95-51CF-0E118F160025}"/>
              </a:ext>
            </a:extLst>
          </p:cNvPr>
          <p:cNvGrpSpPr/>
          <p:nvPr/>
        </p:nvGrpSpPr>
        <p:grpSpPr>
          <a:xfrm>
            <a:off x="739251" y="1498600"/>
            <a:ext cx="3595682" cy="2701364"/>
            <a:chOff x="5665426" y="2039780"/>
            <a:chExt cx="3595682" cy="2701364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xmlns="" id="{B5FD8510-A937-62F6-BA4B-BB30FA58B0F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9976" r="37362" b="8864"/>
            <a:stretch/>
          </p:blipFill>
          <p:spPr>
            <a:xfrm>
              <a:off x="5665426" y="2039780"/>
              <a:ext cx="3595682" cy="2484094"/>
            </a:xfrm>
            <a:prstGeom prst="rect">
              <a:avLst/>
            </a:prstGeom>
          </p:spPr>
        </p:pic>
        <p:pic>
          <p:nvPicPr>
            <p:cNvPr id="7" name="Picture 6" descr="A close-up of numbers&#10;&#10;Description automatically generated">
              <a:extLst>
                <a:ext uri="{FF2B5EF4-FFF2-40B4-BE49-F238E27FC236}">
                  <a16:creationId xmlns:a16="http://schemas.microsoft.com/office/drawing/2014/main" xmlns="" id="{FC9E73DF-843B-54E9-A610-B0C9EE37E67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729766" y="4118844"/>
              <a:ext cx="1816100" cy="622300"/>
            </a:xfrm>
            <a:prstGeom prst="rect">
              <a:avLst/>
            </a:prstGeom>
          </p:spPr>
        </p:pic>
        <p:pic>
          <p:nvPicPr>
            <p:cNvPr id="8" name="Picture 7" descr="A close-up of a number&#10;&#10;Description automatically generated">
              <a:extLst>
                <a:ext uri="{FF2B5EF4-FFF2-40B4-BE49-F238E27FC236}">
                  <a16:creationId xmlns:a16="http://schemas.microsoft.com/office/drawing/2014/main" xmlns="" id="{7B34F8B3-76A8-E924-24ED-A69EB3F111A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8243"/>
            <a:stretch/>
          </p:blipFill>
          <p:spPr>
            <a:xfrm>
              <a:off x="7392202" y="4108284"/>
              <a:ext cx="1596486" cy="558800"/>
            </a:xfrm>
            <a:prstGeom prst="rect">
              <a:avLst/>
            </a:prstGeom>
          </p:spPr>
        </p:pic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xmlns="" id="{0551D00B-B5BB-AE0A-A01B-038DC37585B1}"/>
              </a:ext>
            </a:extLst>
          </p:cNvPr>
          <p:cNvGrpSpPr/>
          <p:nvPr/>
        </p:nvGrpSpPr>
        <p:grpSpPr>
          <a:xfrm>
            <a:off x="4573202" y="1498600"/>
            <a:ext cx="5913507" cy="3275831"/>
            <a:chOff x="5474902" y="1498600"/>
            <a:chExt cx="5913507" cy="3275831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xmlns="" id="{017CB9F4-13AB-0AE7-C736-F2762FE5DA2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5437" b="66253"/>
            <a:stretch/>
          </p:blipFill>
          <p:spPr>
            <a:xfrm>
              <a:off x="5474902" y="1498600"/>
              <a:ext cx="5913507" cy="2079064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xmlns="" id="{6B93E684-04A7-1F0D-9222-11F0834EF71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4801" t="77590" r="36568" b="7821"/>
            <a:stretch/>
          </p:blipFill>
          <p:spPr>
            <a:xfrm>
              <a:off x="5536554" y="3586859"/>
              <a:ext cx="3187700" cy="1187572"/>
            </a:xfrm>
            <a:prstGeom prst="rect">
              <a:avLst/>
            </a:prstGeom>
          </p:spPr>
        </p:pic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7FA69514-9F4D-1316-DD32-8EA95028A689}"/>
              </a:ext>
            </a:extLst>
          </p:cNvPr>
          <p:cNvSpPr txBox="1"/>
          <p:nvPr/>
        </p:nvSpPr>
        <p:spPr>
          <a:xfrm>
            <a:off x="332621" y="1355390"/>
            <a:ext cx="574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0A506451-5ECA-6CD6-F2BB-0F8BBEDE6685}"/>
              </a:ext>
            </a:extLst>
          </p:cNvPr>
          <p:cNvSpPr txBox="1"/>
          <p:nvPr/>
        </p:nvSpPr>
        <p:spPr>
          <a:xfrm>
            <a:off x="4203310" y="1355390"/>
            <a:ext cx="5749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131349252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686ACBF7-90CC-C2E0-6981-85BB87FF3D4F}"/>
              </a:ext>
            </a:extLst>
          </p:cNvPr>
          <p:cNvSpPr txBox="1"/>
          <p:nvPr/>
        </p:nvSpPr>
        <p:spPr>
          <a:xfrm>
            <a:off x="130338" y="33697"/>
            <a:ext cx="1174023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Preclinical efficacy</a:t>
            </a:r>
            <a:r>
              <a:rPr kumimoji="0" lang="en-US" sz="1200" b="1" i="0" u="none" strike="noStrike" kern="120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kumimoji="0" 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TRA and PLB treatment 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n LGSOC cell lines and their acquired-drug resistance </a:t>
            </a:r>
            <a:r>
              <a:rPr lang="en-US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rivatives</a:t>
            </a:r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iOvCa241 cell line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RA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mutant and TRA-more sensitive) and its corresponding acquired TRA-resistant cell line derivative (iOvCa241_TRA_R). B) VOA6406 cell line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RA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wild type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RA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mutant and TRA-less sensitive) and its corresponding acquired TRA- and PLB-resistant cell line derivatives (VOA6406_TRA_SR and VOA6406_PLB_SR). Multiple t-test comparing parental to acquired drug resistant cell lines. (*) p-value less than 0.05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1ABE3FCA-DE88-AF8C-F3BA-85168BB9586E}"/>
              </a:ext>
            </a:extLst>
          </p:cNvPr>
          <p:cNvSpPr txBox="1"/>
          <p:nvPr/>
        </p:nvSpPr>
        <p:spPr>
          <a:xfrm>
            <a:off x="6292040" y="191787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CF70FBEF-89AF-D7A9-464A-1F0F50E974B6}"/>
              </a:ext>
            </a:extLst>
          </p:cNvPr>
          <p:cNvSpPr txBox="1"/>
          <p:nvPr/>
        </p:nvSpPr>
        <p:spPr>
          <a:xfrm>
            <a:off x="653085" y="1875038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xmlns="" id="{F6469634-0684-B46B-DDC7-05C82BF0D57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06062" y="1333044"/>
            <a:ext cx="4723165" cy="3849232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xmlns="" id="{2CD8936F-75DB-6B76-11AD-345EE1C323F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00604" y="2301866"/>
            <a:ext cx="4995396" cy="28804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58805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18</TotalTime>
  <Words>470</Words>
  <Application>Microsoft Macintosh PowerPoint</Application>
  <PresentationFormat>Custom</PresentationFormat>
  <Paragraphs>43</Paragraphs>
  <Slides>6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bittner@student.ubc.ca</dc:creator>
  <cp:lastModifiedBy>Marta Llauradó</cp:lastModifiedBy>
  <cp:revision>309</cp:revision>
  <dcterms:created xsi:type="dcterms:W3CDTF">2023-08-23T23:02:41Z</dcterms:created>
  <dcterms:modified xsi:type="dcterms:W3CDTF">2026-01-28T23:45:46Z</dcterms:modified>
</cp:coreProperties>
</file>